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333" autoAdjust="0"/>
  </p:normalViewPr>
  <p:slideViewPr>
    <p:cSldViewPr>
      <p:cViewPr>
        <p:scale>
          <a:sx n="130" d="100"/>
          <a:sy n="130" d="100"/>
        </p:scale>
        <p:origin x="-360" y="-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807DC7-7B80-4FAA-A8B4-D852E626D2F3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DA75A6-524B-4026-8444-3C9635F96D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Rectangle 288"/>
          <p:cNvSpPr/>
          <p:nvPr/>
        </p:nvSpPr>
        <p:spPr>
          <a:xfrm>
            <a:off x="152400" y="471383"/>
            <a:ext cx="33528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Table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nformation of primers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92" name="Table 291"/>
          <p:cNvGraphicFramePr>
            <a:graphicFrameLocks noGrp="1"/>
          </p:cNvGraphicFramePr>
          <p:nvPr/>
        </p:nvGraphicFramePr>
        <p:xfrm>
          <a:off x="228600" y="914400"/>
          <a:ext cx="6324600" cy="7536180"/>
        </p:xfrm>
        <a:graphic>
          <a:graphicData uri="http://schemas.openxmlformats.org/drawingml/2006/table">
            <a:tbl>
              <a:tblPr/>
              <a:tblGrid>
                <a:gridCol w="2209800"/>
                <a:gridCol w="4114800"/>
              </a:tblGrid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Nam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Sequence (5’-3’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α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ggagtacgtcctgct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α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ctcagcatcttcaat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β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CACCTGGGCTCTAGTTG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β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ACAGTCCTCGTAGCTCTTG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tccagcaccatcgtagaggat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atctcacattcattcgtggct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F (-1460/-1325) 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Agaagcagcccctacact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R (-1460/-1325) 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cagcctggcctaca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-428/-264) 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catgagttctttgc</a:t>
                      </a:r>
                      <a:endParaRPr lang="en-US" sz="1000" b="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-428/-264) 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tcctaccctcacacac</a:t>
                      </a:r>
                      <a:endParaRPr lang="en-US" sz="100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</a:t>
                      </a: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Gtttcttacaccttaaactgagtcaccat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</a:t>
                      </a:r>
                      <a:r>
                        <a:rPr lang="en-US" sz="1000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nti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Ttatggtgactcagtttaaggtgtaagaaa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HOP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tggctactttggatgaaa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HOP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aaagactttgagtatttggc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XBP1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cacgcttgggaatggaca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XBP1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catgggaagatgttctgg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4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ggctgaagaaagcctaggt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4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caacatccaatctgtccc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α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ctcagctgatggctgt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α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gggtggtagctggta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REBH F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solidFill>
                            <a:srgbClr val="000000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ctcactgtgaaggaactgct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REBH R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AGCAGCTTCTTCTCATCCT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F (-2482/-2375)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GulimChe"/>
                          <a:cs typeface="Arial" pitchFamily="34" charset="0"/>
                        </a:rPr>
                        <a:t>CT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GulimChe"/>
                          <a:cs typeface="Arial" pitchFamily="34" charset="0"/>
                        </a:rPr>
                        <a:t>AGAGTTACAGATGGTT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R (-2482/-2375)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cctccctcccaga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-732/-551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TGGAATCCGTGATG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-732/-551)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ttgtagaaaacccacc</a:t>
                      </a:r>
                      <a:endParaRPr lang="en-US" sz="100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solidFill>
                            <a:srgbClr val="000000"/>
                          </a:solidFill>
                          <a:latin typeface="Arial" pitchFamily="34" charset="0"/>
                          <a:ea typeface="GulimChe"/>
                          <a:cs typeface="Arial" pitchFamily="34" charset="0"/>
                        </a:rPr>
                        <a:t>gtgggagctgagaactgaacccatttcctctgcaagaata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moter anti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solidFill>
                            <a:srgbClr val="000000"/>
                          </a:solidFill>
                          <a:latin typeface="Arial" pitchFamily="34" charset="0"/>
                          <a:ea typeface="GulimChe"/>
                          <a:cs typeface="Arial" pitchFamily="34" charset="0"/>
                        </a:rPr>
                        <a:t>ctattcttgcagaggaaatgggttcagttctcagctcccac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9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GRP78 Promoter 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acgagtagcgagttcattaatcggaggcctccac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utant GRP78 Promoter antisense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cap="all" dirty="0" err="1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gtggaggcctccgattaatgaactcgctactcgtt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1.254 kb)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cttgatacgcgtGAAGATGTGCTTTACCTC</a:t>
                      </a:r>
                      <a:endParaRPr lang="en-US" sz="100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1.254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attcgatctcgagaccgaggctcgcacactctctcc</a:t>
                      </a:r>
                      <a:endParaRPr lang="en-US" sz="100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0.5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CGCAGAATCCTTCGGCCAAATCTATCG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ERRγ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0.5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attcgatctcgagaccgaggctcgcacactctctcc</a:t>
                      </a:r>
                      <a:endParaRPr lang="en-US" sz="1000" cap="all" baseline="0" dirty="0" smtClean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2.6 kb)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sv-SE" sz="10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TAGGTTACCACTAGAGTA</a:t>
                      </a:r>
                      <a:endParaRPr lang="en-US" sz="100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2.6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kern="1200" cap="all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ccccagtcttcatctggtc</a:t>
                      </a:r>
                      <a:endParaRPr lang="en-US" sz="1000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2.3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AACAGGAATGACAAATGGTTGAGGCTGG</a:t>
                      </a:r>
                      <a:endParaRPr lang="en-US" sz="1000" u="none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2.3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GAGGAAGAACCGGACTAAAAGGCGACT</a:t>
                      </a:r>
                      <a:endParaRPr lang="en-US" sz="1000" u="none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1.0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CTTCACGAATTCTGACCTGGCTTTCCTC</a:t>
                      </a:r>
                      <a:endParaRPr lang="en-US" sz="1000" b="0" u="none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1.0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GAGGAAGAACCGGACTAAAAGGCGACT</a:t>
                      </a:r>
                      <a:endParaRPr lang="en-US" sz="1000" u="none" cap="all" baseline="0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F (0.5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AGTGGTTCTAACACATGTCGGAAATTTG</a:t>
                      </a:r>
                      <a:endParaRPr lang="en-US" sz="1000" u="none" dirty="0">
                        <a:solidFill>
                          <a:schemeClr val="tx1"/>
                        </a:solidFill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3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TF6</a:t>
                      </a:r>
                      <a:r>
                        <a:rPr lang="el-GR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α</a:t>
                      </a:r>
                      <a:r>
                        <a:rPr lang="en-US" sz="1000" dirty="0" smtClean="0"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promoter R (0.5 kb)</a:t>
                      </a: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u="non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GAGGAAGAACCGGACTAAAAGGCGACT</a:t>
                      </a:r>
                      <a:endParaRPr lang="en-US" sz="1000" u="none" dirty="0"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142" marR="36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37</TotalTime>
  <Words>273</Words>
  <Application>Microsoft Office PowerPoint</Application>
  <PresentationFormat>On-screen Show (4:3)</PresentationFormat>
  <Paragraphs>8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605</cp:revision>
  <dcterms:created xsi:type="dcterms:W3CDTF">2010-12-16T12:09:59Z</dcterms:created>
  <dcterms:modified xsi:type="dcterms:W3CDTF">2013-04-09T08:43:39Z</dcterms:modified>
</cp:coreProperties>
</file>